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309" r:id="rId2"/>
    <p:sldId id="311" r:id="rId3"/>
    <p:sldId id="300" r:id="rId4"/>
    <p:sldId id="313" r:id="rId5"/>
    <p:sldId id="319" r:id="rId6"/>
    <p:sldId id="314" r:id="rId7"/>
    <p:sldId id="305" r:id="rId8"/>
    <p:sldId id="322" r:id="rId9"/>
    <p:sldId id="320" r:id="rId10"/>
    <p:sldId id="321" r:id="rId11"/>
    <p:sldId id="302" r:id="rId12"/>
    <p:sldId id="258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420" autoAdjust="0"/>
    <p:restoredTop sz="66067" autoAdjust="0"/>
  </p:normalViewPr>
  <p:slideViewPr>
    <p:cSldViewPr snapToGrid="0">
      <p:cViewPr varScale="1">
        <p:scale>
          <a:sx n="82" d="100"/>
          <a:sy n="82" d="100"/>
        </p:scale>
        <p:origin x="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9E6C9F-D42C-4817-85BC-89B796EEA6C7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FADAF1-6E6A-4F3E-AE3A-086FC703F0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1131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1. Surface HLA-A2 Expression vs. Overall HLA-A*0201 in KG-1 Cells Transduced with Different SCTs</a:t>
            </a:r>
            <a:r>
              <a:rPr lang="en-US" b="0" dirty="0"/>
              <a:t>. </a:t>
            </a:r>
            <a:r>
              <a:rPr lang="en-US" b="1" dirty="0"/>
              <a:t>(A) </a:t>
            </a:r>
            <a:r>
              <a:rPr lang="en-US" b="0" dirty="0"/>
              <a:t>Schematic representation of the single-chain trimer (SCT) chimeric protein. HLA-A0201 SCTs bearing different Y320 mutations were tagged with </a:t>
            </a:r>
            <a:r>
              <a:rPr lang="en-US" b="0" dirty="0" err="1"/>
              <a:t>eYFP</a:t>
            </a:r>
            <a:r>
              <a:rPr lang="en-US" b="0" dirty="0"/>
              <a:t> at the end of the intracellular domain. </a:t>
            </a:r>
            <a:r>
              <a:rPr lang="en-US" b="1" dirty="0"/>
              <a:t>(B) </a:t>
            </a:r>
            <a:r>
              <a:rPr lang="en-US" b="0" dirty="0"/>
              <a:t>Surface HLA-A0201 expression was assessed using BB7.2-APC antibody staining, </a:t>
            </a:r>
            <a:r>
              <a:rPr lang="en-US" b="0" dirty="0" err="1"/>
              <a:t>eYFP</a:t>
            </a:r>
            <a:r>
              <a:rPr lang="en-US" b="0" dirty="0"/>
              <a:t> suggested the transcript level of HLA SCTs. MFI values for </a:t>
            </a:r>
            <a:r>
              <a:rPr lang="en-US" b="0" dirty="0" err="1"/>
              <a:t>eYFP</a:t>
            </a:r>
            <a:r>
              <a:rPr lang="en-US" b="0" dirty="0"/>
              <a:t>: Parental = 204, WT = 8,625, Y320F = 8,974, Y320E = 9,649. MFI values for APC: Parental = 113, WT = 17,589, Y320F = 12,238, Y320E = 13,530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FADAF1-6E6A-4F3E-AE3A-086FC703F04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209881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 Figure 2</a:t>
            </a:r>
            <a:r>
              <a:rPr lang="en-US" dirty="0"/>
              <a:t>. </a:t>
            </a:r>
            <a:r>
              <a:rPr lang="en-US" sz="1200" b="0" dirty="0">
                <a:latin typeface="Arial" panose="020B0604020202020204" pitchFamily="34" charset="0"/>
                <a:cs typeface="Arial" panose="020B0604020202020204" pitchFamily="34" charset="0"/>
              </a:rPr>
              <a:t>Other gene expression levels of selected genes in WT-, Y320F-, and Y320E primed T cells. Each data point represents an individual donor, with paired comparisons performed using a two-tailed paired Student’s t-test. Data are presented as mean ± standard deviation (SD) from n = 3 donors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729F8A-94EB-4363-86DB-98137A4F1BCF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99085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l Figure 3. </a:t>
            </a:r>
            <a:r>
              <a:rPr lang="en-US" dirty="0"/>
              <a:t>Surface OVA-</a:t>
            </a:r>
            <a:r>
              <a:rPr lang="en-US" dirty="0" err="1"/>
              <a:t>Kb</a:t>
            </a:r>
            <a:r>
              <a:rPr lang="en-US" dirty="0"/>
              <a:t> Expression and Phenotypic Analysis of OVA-Specific T Cells Post-Vaccination. </a:t>
            </a:r>
            <a:r>
              <a:rPr lang="en-US" b="1" dirty="0"/>
              <a:t>(A) S</a:t>
            </a:r>
            <a:r>
              <a:rPr lang="en-US" sz="1800" u="none" strike="noStrike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chematics of the SCTs and s</a:t>
            </a:r>
            <a:r>
              <a:rPr lang="en-US" dirty="0"/>
              <a:t>urface expression of OVA-</a:t>
            </a:r>
            <a:r>
              <a:rPr lang="en-US" dirty="0" err="1"/>
              <a:t>Kb</a:t>
            </a:r>
            <a:r>
              <a:rPr lang="en-US" dirty="0"/>
              <a:t> on DC2.4 cells assessed by flow cytometry.</a:t>
            </a:r>
            <a:r>
              <a:rPr lang="en-US" b="1" dirty="0"/>
              <a:t> (B) </a:t>
            </a:r>
            <a:r>
              <a:rPr lang="en-US" dirty="0"/>
              <a:t>CD127 expression in donor and endogenous peripheral OVA-specific T cells across different vaccination groups at various time points. </a:t>
            </a:r>
            <a:r>
              <a:rPr lang="en-US" b="1" dirty="0"/>
              <a:t>(C) </a:t>
            </a:r>
            <a:r>
              <a:rPr lang="en-US" dirty="0"/>
              <a:t>KLRG1 expression in donor and endogenous peripheral OVA-specific T cells across different vaccination groups at various time points. Statistical differences between Y320 mutants were assessed using one-way ANOVA, followed by pairwise comparisons using an unpaired two-tailed t-test.</a:t>
            </a:r>
            <a:r>
              <a:rPr lang="en-US" sz="1200" b="0" dirty="0">
                <a:latin typeface="Arial" panose="020B0604020202020204" pitchFamily="34" charset="0"/>
                <a:cs typeface="Arial" panose="020B0604020202020204" pitchFamily="34" charset="0"/>
              </a:rPr>
              <a:t> Data are presented as mean ± standard error of the mean (SEM). Statistically significant p values (p &lt; 0.05) are indicated in the figure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729F8A-94EB-4363-86DB-98137A4F1BCF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44396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l Figure 4. </a:t>
            </a:r>
            <a:r>
              <a:rPr lang="en-US" dirty="0"/>
              <a:t>Tumor infiltrated T cell surface marker expression in different DC2.4 vaccinated mice. </a:t>
            </a:r>
            <a:r>
              <a:rPr lang="en-US" sz="1800" dirty="0"/>
              <a:t>Statistical differences between Y320 mutants were assessed using one-way ANOVA, followed by pairwise comparisons using an unpaired two-tailed t-test.</a:t>
            </a:r>
            <a:r>
              <a:rPr lang="en-US" sz="1800" b="0" dirty="0">
                <a:latin typeface="Arial" panose="020B0604020202020204" pitchFamily="34" charset="0"/>
                <a:cs typeface="Arial" panose="020B0604020202020204" pitchFamily="34" charset="0"/>
              </a:rPr>
              <a:t> Data are presented as mean ± standard error of the mean (SEM). </a:t>
            </a:r>
            <a:endParaRPr lang="en-US" sz="18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729F8A-94EB-4363-86DB-98137A4F1BCF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081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BB23EA-867E-1342-7162-1B542466763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CD94448-517C-5A11-787C-56CE7D6476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533FC2-0655-1DE8-887B-1BE11D25AE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E1785-DDE2-43A2-937F-53AD0A79620C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D72970-BA1D-AD4A-C14C-1C566D6AD1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AFB4CD-42C9-723D-1160-4140D1FF16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4199-13E1-4D2E-96B4-26891598B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3284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9BBA9C-5BE5-B379-4EDD-93E6EF92D2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521AE71-A66F-0427-0739-6EFE4FD285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20FC3C-BE45-5D82-95F8-6D12FA7AC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E1785-DDE2-43A2-937F-53AD0A79620C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A348BF-2FC4-249A-E297-B88EA86020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00CD76-25F5-3EE2-BE10-A84D8D1C0C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4199-13E1-4D2E-96B4-26891598B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9595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313F22C-B721-B126-8A61-69FABB3081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EC86CEA-3977-D379-19B3-984FB496C8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A72D73-2AB2-C2BB-CB7F-2FDE0A3EA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E1785-DDE2-43A2-937F-53AD0A79620C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5154D1-6D32-AEFC-A0E7-6E6FE651D0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92E04F-5E36-B5F5-D7A3-2511183A2C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4199-13E1-4D2E-96B4-26891598B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51241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AFA205-B2CB-84E7-9FFF-958A6C5FA0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0F98FA-4F66-7910-32F9-8D87CF4F2FC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C2C1A2-D1F8-3473-E248-A277BDD3E7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E1785-DDE2-43A2-937F-53AD0A79620C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6B8387-60C4-7D4E-9031-3ADB87975B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6FA6B1-4D87-5CDE-BCEB-057BFD0C39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4199-13E1-4D2E-96B4-26891598B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5721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FE824C-DB61-D418-7147-BEFED04471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71FF54-1429-DF10-0A09-40CD5AD6B4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A85054-ACEE-444D-3064-5F512037CA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E1785-DDE2-43A2-937F-53AD0A79620C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01E964-06F1-0966-D64E-2D143CDE4E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F573CA-6AE3-BC43-C70A-AF39B2A8E0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4199-13E1-4D2E-96B4-26891598B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88814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B977D3-A53B-525E-4C01-9C17700B36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35AC388-CCF9-44F4-0B8E-DBB0FAAB6FD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0FE90AF-B751-066B-0D65-79F79C253B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3ABD44-5318-D17D-A381-B9BE512869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E1785-DDE2-43A2-937F-53AD0A79620C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0494FF-90AE-5DCF-4652-3D9D69008E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F26CA9-7493-236C-D0C4-F791128F8B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4199-13E1-4D2E-96B4-26891598B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8776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3F7FB6-DBC8-540D-B238-05A8C74009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2184A0-C650-5C85-627E-D072064480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5435FE-19FD-116E-ABDC-35440809FB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BBEA9A5-2787-27FC-DA43-3DF3C2015FA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B9DD5AD-EFCB-90F4-878D-CA5B0822370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4BD3C48-DD17-5F53-C4DE-1DEBB24792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E1785-DDE2-43A2-937F-53AD0A79620C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0234A40-5C6B-C64D-A3B5-2130167B08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841ABB2-3D15-2FBE-9272-592C62457F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4199-13E1-4D2E-96B4-26891598B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6318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F59790-17F9-91E4-2408-0A7695245B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58860C1-9B77-FB70-D9E1-AA1740A334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E1785-DDE2-43A2-937F-53AD0A79620C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9FB3AB0-F733-CD59-72EB-FED1FB109D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B7707D2-F9B1-ABF6-DC8D-30A598C9C3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4199-13E1-4D2E-96B4-26891598B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2549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A90FD25-90EA-623B-AE6E-80E12A177E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E1785-DDE2-43A2-937F-53AD0A79620C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FC973EC-9E99-C69F-C424-130FA3252C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737FC8C-7AFE-6575-77DE-066AFC6ED7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4199-13E1-4D2E-96B4-26891598B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24601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70CC4D-03CB-23A6-341D-5C2F4F20E3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7E4B6F-D112-F612-20D9-FA52137A8EB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677F98C-254C-EAD1-F922-D82C38B916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FC71BA0-BF5A-FE9F-3CB1-FCA04812C1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E1785-DDE2-43A2-937F-53AD0A79620C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891F24-024B-FED4-4435-276FBCB4CA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C2FAED-B15B-9A67-8B80-32D524E09B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4199-13E1-4D2E-96B4-26891598B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60193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1AE289-B4E2-ECB8-0BEB-D6CE387331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199A4FC-F85D-8A6D-3A44-D03722B4EBB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41A300C-59CD-14E9-CFB2-16B108A288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EF15B9-FF97-E682-C895-1592AD065D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E1785-DDE2-43A2-937F-53AD0A79620C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6E9C7E-0B9A-07B4-2DDC-3B141BE93B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17CA67-17B3-DACC-4910-7B8EFA5BBE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94199-13E1-4D2E-96B4-26891598B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2493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E8E96F2-9BD9-481A-13B4-66B9BCE483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F4DA36-5C69-6F5D-4BD4-E33E4CF5A8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4F6092-509D-A891-8D04-7E557FAD490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6DE1785-DDE2-43A2-937F-53AD0A79620C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E2128E-383B-403D-CED3-DBBE58386C1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7632AC-E090-FCA7-9CFD-6820DDA5160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6194199-13E1-4D2E-96B4-26891598B5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6541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emf"/><Relationship Id="rId3" Type="http://schemas.openxmlformats.org/officeDocument/2006/relationships/image" Target="../media/image38.emf"/><Relationship Id="rId7" Type="http://schemas.openxmlformats.org/officeDocument/2006/relationships/image" Target="../media/image41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0.emf"/><Relationship Id="rId5" Type="http://schemas.openxmlformats.org/officeDocument/2006/relationships/image" Target="../media/image39.emf"/><Relationship Id="rId4" Type="http://schemas.openxmlformats.org/officeDocument/2006/relationships/oleObject" Target="../embeddings/oleObject9.bin"/><Relationship Id="rId9" Type="http://schemas.openxmlformats.org/officeDocument/2006/relationships/image" Target="../media/image43.emf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7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6.emf"/><Relationship Id="rId4" Type="http://schemas.openxmlformats.org/officeDocument/2006/relationships/image" Target="../media/image3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microsoft.com/office/2007/relationships/hdphoto" Target="../media/hdphoto4.wdp"/><Relationship Id="rId3" Type="http://schemas.openxmlformats.org/officeDocument/2006/relationships/image" Target="../media/image10.png"/><Relationship Id="rId7" Type="http://schemas.openxmlformats.org/officeDocument/2006/relationships/image" Target="../media/image13.png"/><Relationship Id="rId12" Type="http://schemas.openxmlformats.org/officeDocument/2006/relationships/image" Target="../media/image16.png"/><Relationship Id="rId17" Type="http://schemas.openxmlformats.org/officeDocument/2006/relationships/image" Target="../media/image20.png"/><Relationship Id="rId2" Type="http://schemas.openxmlformats.org/officeDocument/2006/relationships/image" Target="../media/image9.png"/><Relationship Id="rId16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11" Type="http://schemas.openxmlformats.org/officeDocument/2006/relationships/image" Target="../media/image15.png"/><Relationship Id="rId5" Type="http://schemas.openxmlformats.org/officeDocument/2006/relationships/image" Target="../media/image12.png"/><Relationship Id="rId15" Type="http://schemas.openxmlformats.org/officeDocument/2006/relationships/image" Target="../media/image18.png"/><Relationship Id="rId10" Type="http://schemas.microsoft.com/office/2007/relationships/hdphoto" Target="../media/hdphoto3.wdp"/><Relationship Id="rId4" Type="http://schemas.openxmlformats.org/officeDocument/2006/relationships/image" Target="../media/image11.png"/><Relationship Id="rId9" Type="http://schemas.openxmlformats.org/officeDocument/2006/relationships/image" Target="../media/image14.png"/><Relationship Id="rId14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emf"/><Relationship Id="rId13" Type="http://schemas.openxmlformats.org/officeDocument/2006/relationships/image" Target="../media/image30.emf"/><Relationship Id="rId3" Type="http://schemas.openxmlformats.org/officeDocument/2006/relationships/image" Target="../media/image21.emf"/><Relationship Id="rId7" Type="http://schemas.openxmlformats.org/officeDocument/2006/relationships/image" Target="../media/image25.emf"/><Relationship Id="rId12" Type="http://schemas.openxmlformats.org/officeDocument/2006/relationships/image" Target="../media/image29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emf"/><Relationship Id="rId11" Type="http://schemas.openxmlformats.org/officeDocument/2006/relationships/image" Target="../media/image28.emf"/><Relationship Id="rId5" Type="http://schemas.openxmlformats.org/officeDocument/2006/relationships/image" Target="../media/image23.emf"/><Relationship Id="rId15" Type="http://schemas.openxmlformats.org/officeDocument/2006/relationships/image" Target="../media/image32.emf"/><Relationship Id="rId10" Type="http://schemas.openxmlformats.org/officeDocument/2006/relationships/image" Target="../media/image27.emf"/><Relationship Id="rId4" Type="http://schemas.openxmlformats.org/officeDocument/2006/relationships/image" Target="../media/image22.emf"/><Relationship Id="rId9" Type="http://schemas.openxmlformats.org/officeDocument/2006/relationships/oleObject" Target="../embeddings/oleObject7.bin"/><Relationship Id="rId14" Type="http://schemas.openxmlformats.org/officeDocument/2006/relationships/image" Target="../media/image31.e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emf"/><Relationship Id="rId7" Type="http://schemas.openxmlformats.org/officeDocument/2006/relationships/image" Target="../media/image37.png"/><Relationship Id="rId2" Type="http://schemas.openxmlformats.org/officeDocument/2006/relationships/oleObject" Target="../embeddings/oleObject8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.emf"/><Relationship Id="rId5" Type="http://schemas.openxmlformats.org/officeDocument/2006/relationships/image" Target="../media/image35.emf"/><Relationship Id="rId4" Type="http://schemas.openxmlformats.org/officeDocument/2006/relationships/image" Target="../media/image3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94716171-CDB8-F8B7-98BC-A02542D27E25}"/>
              </a:ext>
            </a:extLst>
          </p:cNvPr>
          <p:cNvSpPr/>
          <p:nvPr/>
        </p:nvSpPr>
        <p:spPr>
          <a:xfrm>
            <a:off x="570271" y="1258529"/>
            <a:ext cx="855406" cy="45228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ysClr val="windowText" lastClr="000000"/>
                </a:solidFill>
              </a:rPr>
              <a:t>A.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5DC55455-1679-D7A8-57C4-BB5C31B32B62}"/>
              </a:ext>
            </a:extLst>
          </p:cNvPr>
          <p:cNvGrpSpPr/>
          <p:nvPr/>
        </p:nvGrpSpPr>
        <p:grpSpPr>
          <a:xfrm>
            <a:off x="827176" y="1174308"/>
            <a:ext cx="4249799" cy="4825643"/>
            <a:chOff x="5607724" y="702059"/>
            <a:chExt cx="4249799" cy="4825643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51116E71-4D71-9941-CD6D-2B8C9165E2D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862466" y="702059"/>
              <a:ext cx="3995057" cy="4611316"/>
            </a:xfrm>
            <a:prstGeom prst="rect">
              <a:avLst/>
            </a:prstGeom>
          </p:spPr>
        </p:pic>
        <p:cxnSp>
          <p:nvCxnSpPr>
            <p:cNvPr id="10" name="Straight Arrow Connector 9">
              <a:extLst>
                <a:ext uri="{FF2B5EF4-FFF2-40B4-BE49-F238E27FC236}">
                  <a16:creationId xmlns:a16="http://schemas.microsoft.com/office/drawing/2014/main" id="{16B9882A-CFA5-B819-9212-9E3CDA89D6DE}"/>
                </a:ext>
              </a:extLst>
            </p:cNvPr>
            <p:cNvCxnSpPr/>
            <p:nvPr/>
          </p:nvCxnSpPr>
          <p:spPr>
            <a:xfrm>
              <a:off x="6380677" y="5136336"/>
              <a:ext cx="347684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CF533D8-3E56-8E3F-CEC7-5609DC9DF8F7}"/>
                </a:ext>
              </a:extLst>
            </p:cNvPr>
            <p:cNvSpPr txBox="1"/>
            <p:nvPr/>
          </p:nvSpPr>
          <p:spPr>
            <a:xfrm>
              <a:off x="7367792" y="5158370"/>
              <a:ext cx="182880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dirty="0"/>
                <a:t>HLA-A2 SCTs</a:t>
              </a:r>
            </a:p>
          </p:txBody>
        </p: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CC442ED1-4A85-097A-B383-3007D71FE50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096000" y="1722621"/>
              <a:ext cx="0" cy="298883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93431D0-800A-11E1-B23B-1A7DA148EAAA}"/>
                </a:ext>
              </a:extLst>
            </p:cNvPr>
            <p:cNvSpPr txBox="1"/>
            <p:nvPr/>
          </p:nvSpPr>
          <p:spPr>
            <a:xfrm rot="16200000">
              <a:off x="4877990" y="2452355"/>
              <a:ext cx="182880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eYFP</a:t>
              </a:r>
              <a:endParaRPr lang="en-US" dirty="0"/>
            </a:p>
          </p:txBody>
        </p:sp>
      </p:grpSp>
      <p:sp>
        <p:nvSpPr>
          <p:cNvPr id="3" name="Rectangle 2">
            <a:extLst>
              <a:ext uri="{FF2B5EF4-FFF2-40B4-BE49-F238E27FC236}">
                <a16:creationId xmlns:a16="http://schemas.microsoft.com/office/drawing/2014/main" id="{73B3F395-2A4F-BA6F-3E02-EC71A95993FF}"/>
              </a:ext>
            </a:extLst>
          </p:cNvPr>
          <p:cNvSpPr/>
          <p:nvPr/>
        </p:nvSpPr>
        <p:spPr>
          <a:xfrm>
            <a:off x="6833935" y="1126182"/>
            <a:ext cx="855406" cy="76264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ysClr val="windowText" lastClr="000000"/>
                </a:solidFill>
              </a:rPr>
              <a:t>B.</a:t>
            </a:r>
          </a:p>
        </p:txBody>
      </p:sp>
      <p:pic>
        <p:nvPicPr>
          <p:cNvPr id="6" name="Picture 5" descr="A diagram of a structure&#10;&#10;AI-generated content may be incorrect.">
            <a:extLst>
              <a:ext uri="{FF2B5EF4-FFF2-40B4-BE49-F238E27FC236}">
                <a16:creationId xmlns:a16="http://schemas.microsoft.com/office/drawing/2014/main" id="{F987245C-3993-239B-4D01-BF33EEBECF7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80" t="24554" r="41929" b="24404"/>
          <a:stretch/>
        </p:blipFill>
        <p:spPr>
          <a:xfrm>
            <a:off x="7458077" y="1846431"/>
            <a:ext cx="3300156" cy="326707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A08D37B-1E49-DE27-F743-FDE7681DD608}"/>
              </a:ext>
            </a:extLst>
          </p:cNvPr>
          <p:cNvSpPr txBox="1"/>
          <p:nvPr/>
        </p:nvSpPr>
        <p:spPr>
          <a:xfrm>
            <a:off x="413973" y="387726"/>
            <a:ext cx="2670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Figure S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2103444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A9553F1-6A69-D8DF-7094-73E3E56C8AB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B5A8220F-EE7E-EA2B-E1EE-B0C16634A5D2}"/>
              </a:ext>
            </a:extLst>
          </p:cNvPr>
          <p:cNvSpPr txBox="1"/>
          <p:nvPr/>
        </p:nvSpPr>
        <p:spPr>
          <a:xfrm>
            <a:off x="1345319" y="1654690"/>
            <a:ext cx="9175898" cy="25853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dirty="0"/>
              <a:t>Supplemental Figure S5. Splenic T cell phenotypes following DC2.4/SCT vaccination. (A) </a:t>
            </a:r>
            <a:r>
              <a:rPr lang="en-US" dirty="0"/>
              <a:t>Schematic representation of the vaccination protocol. Mice were injected subcutaneously with 1×10^6 irradiated (2000 rads) DC2.4 cells on day 1, and spleens were collected on day 7. (</a:t>
            </a:r>
            <a:r>
              <a:rPr lang="en-US" b="1" dirty="0"/>
              <a:t>B) </a:t>
            </a:r>
            <a:r>
              <a:rPr lang="en-US" dirty="0"/>
              <a:t>Frequencies of OVA-specific CD8+ T cells and distribution of distinct OVA-specific CD8+ T cell subsets in spleens from mice vaccinated with parental, WT, Y320F, or Y320E DC2.4-OVA-SCT constructs. Subsets shown include Tem (CD62L–, KLRG1-, CD127lo), Teff (CD62L–, KLRG1+, CD127lo), and </a:t>
            </a:r>
            <a:r>
              <a:rPr lang="en-US" dirty="0" err="1"/>
              <a:t>Tcm</a:t>
            </a:r>
            <a:r>
              <a:rPr lang="en-US" dirty="0"/>
              <a:t> (CD62L+, KLRG1–, CD127hi) populations. Data are presented as mean ± SEM. Statistical differences between Y320 variant groups were assessed using one-way ANOVA.</a:t>
            </a:r>
            <a:endParaRPr lang="en-US" sz="18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75107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0D9AE27-3B40-B546-034B-8E19783981F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9634" y="619371"/>
            <a:ext cx="3496448" cy="2716985"/>
          </a:xfrm>
          <a:prstGeom prst="rect">
            <a:avLst/>
          </a:prstGeom>
        </p:spPr>
      </p:pic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3020D849-D307-7543-6DE7-E1253F71DDC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364757" y="520755"/>
          <a:ext cx="3496448" cy="29082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727765" imgH="3100366" progId="Prism10.Document">
                  <p:embed/>
                </p:oleObj>
              </mc:Choice>
              <mc:Fallback>
                <p:oleObj name="Prism 10" r:id="rId4" imgW="3727765" imgH="3100366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3020D849-D307-7543-6DE7-E1253F71DDC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364757" y="520755"/>
                        <a:ext cx="3496448" cy="29082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0" name="Picture 9">
            <a:extLst>
              <a:ext uri="{FF2B5EF4-FFF2-40B4-BE49-F238E27FC236}">
                <a16:creationId xmlns:a16="http://schemas.microsoft.com/office/drawing/2014/main" id="{2A4ED950-392D-C023-05CD-C2F8A160202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07806" y="3473179"/>
            <a:ext cx="3530350" cy="2716985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F56173A4-0E66-136E-2B0A-A3BB655B10D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89634" y="3398772"/>
            <a:ext cx="3697637" cy="282725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C484C63-C635-BF58-C630-A05C6EDDAEF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483801" y="645927"/>
            <a:ext cx="3697637" cy="271698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64FE286-794C-9A5D-F750-B21969B99BA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612965" y="3488084"/>
            <a:ext cx="3584004" cy="270523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7E7978B-945C-43BE-A8BA-48124CB29D6F}"/>
              </a:ext>
            </a:extLst>
          </p:cNvPr>
          <p:cNvSpPr txBox="1"/>
          <p:nvPr/>
        </p:nvSpPr>
        <p:spPr>
          <a:xfrm>
            <a:off x="251012" y="151423"/>
            <a:ext cx="2670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Figure S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5446655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0AE644D-1997-498F-D398-28E430021915}"/>
              </a:ext>
            </a:extLst>
          </p:cNvPr>
          <p:cNvSpPr txBox="1"/>
          <p:nvPr/>
        </p:nvSpPr>
        <p:spPr>
          <a:xfrm>
            <a:off x="1552353" y="2551837"/>
            <a:ext cx="9175898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dirty="0"/>
              <a:t>Supplemental Figure S6. Surface Marker Expression of Tumor-infiltrating CD8+ T Cells in DC2.4/SCT-vaccinated Mice. </a:t>
            </a:r>
            <a:r>
              <a:rPr lang="en-US" sz="1800" dirty="0"/>
              <a:t>Statistical differences between Y320 groups were assessed using one-way ANOVA, followed by pairwise comparisons using an unpaired two-tailed t-test; </a:t>
            </a:r>
            <a:r>
              <a:rPr lang="en-US" sz="1800" b="0" dirty="0">
                <a:latin typeface="Arial" panose="020B0604020202020204" pitchFamily="34" charset="0"/>
                <a:cs typeface="Arial" panose="020B0604020202020204" pitchFamily="34" charset="0"/>
              </a:rPr>
              <a:t>only significant p values (p &lt; 0.05) are shown</a:t>
            </a:r>
            <a:r>
              <a:rPr lang="en-US" sz="1800" dirty="0"/>
              <a:t>.</a:t>
            </a:r>
            <a:r>
              <a:rPr lang="en-US" sz="1800" b="0" dirty="0">
                <a:latin typeface="Arial" panose="020B0604020202020204" pitchFamily="34" charset="0"/>
                <a:cs typeface="Arial" panose="020B0604020202020204" pitchFamily="34" charset="0"/>
              </a:rPr>
              <a:t> Data are presented as mean ± standard error of the mean (SEM).</a:t>
            </a:r>
            <a:endParaRPr lang="en-US" sz="18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20703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C210321-D17B-92F8-F24A-D00334399552}"/>
              </a:ext>
            </a:extLst>
          </p:cNvPr>
          <p:cNvSpPr txBox="1"/>
          <p:nvPr/>
        </p:nvSpPr>
        <p:spPr>
          <a:xfrm>
            <a:off x="1571625" y="1859340"/>
            <a:ext cx="9172575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l Figure S1. Surface Expression of HLA-A*0201 constructs in KG-1 Cells. (A) </a:t>
            </a:r>
            <a:r>
              <a:rPr lang="en-US" b="0" dirty="0"/>
              <a:t>Surface HLA-A*0201 expression was assessed using BB7.2-APC antibody staining. Expression of </a:t>
            </a:r>
            <a:r>
              <a:rPr lang="en-US" b="0" dirty="0" err="1"/>
              <a:t>eYFP</a:t>
            </a:r>
            <a:r>
              <a:rPr lang="en-US" b="0" dirty="0"/>
              <a:t>, encoded downstream of the same IRES element within the lentiviral vector, served as a surrogate for </a:t>
            </a:r>
            <a:r>
              <a:rPr lang="en-US" dirty="0"/>
              <a:t>HLA-A*0201</a:t>
            </a:r>
            <a:r>
              <a:rPr lang="en-US" b="0" dirty="0"/>
              <a:t> transcript levels. MFI values for </a:t>
            </a:r>
            <a:r>
              <a:rPr lang="en-US" b="0" dirty="0" err="1"/>
              <a:t>eYFP</a:t>
            </a:r>
            <a:r>
              <a:rPr lang="en-US" b="0" dirty="0"/>
              <a:t>: Parental </a:t>
            </a:r>
            <a:r>
              <a:rPr lang="en-US" b="0" dirty="0" err="1"/>
              <a:t>untransduced</a:t>
            </a:r>
            <a:r>
              <a:rPr lang="en-US" b="0" dirty="0"/>
              <a:t> cells = 204, WT = 8,625, Y320F = 8,974, Y320E = 9,649. MFI values for APC: Parental = 113, WT = 17,589, Y320F = 12,238, Y320E = 13,530. </a:t>
            </a:r>
            <a:r>
              <a:rPr lang="en-US" b="1" dirty="0"/>
              <a:t>(B) </a:t>
            </a:r>
            <a:r>
              <a:rPr lang="en-US" b="0" dirty="0"/>
              <a:t>Schematic representation of the HLA-A*0201 single-chain trimer chimeric protein.</a:t>
            </a:r>
          </a:p>
        </p:txBody>
      </p:sp>
    </p:spTree>
    <p:extLst>
      <p:ext uri="{BB962C8B-B14F-4D97-AF65-F5344CB8AC3E}">
        <p14:creationId xmlns:p14="http://schemas.microsoft.com/office/powerpoint/2010/main" val="13570651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985ADEA2-5965-B3F3-E3A1-6676F656FC4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596237" y="698491"/>
          <a:ext cx="2587835" cy="26087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3148306" imgH="3173455" progId="Prism10.Document">
                  <p:embed/>
                </p:oleObj>
              </mc:Choice>
              <mc:Fallback>
                <p:oleObj name="Prism 10" r:id="rId3" imgW="3148306" imgH="3173455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985ADEA2-5965-B3F3-E3A1-6676F656FC4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96237" y="698491"/>
                        <a:ext cx="2587835" cy="260871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D45286C-1238-E092-49DE-E1AC2BC907F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565790" y="3550795"/>
          <a:ext cx="2699020" cy="28838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3012535" imgH="3219181" progId="Prism10.Document">
                  <p:embed/>
                </p:oleObj>
              </mc:Choice>
              <mc:Fallback>
                <p:oleObj name="Prism 10" r:id="rId5" imgW="3012535" imgH="3219181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D45286C-1238-E092-49DE-E1AC2BC907F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565790" y="3550795"/>
                        <a:ext cx="2699020" cy="28838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32CF915E-29E3-7B56-A33A-E34A9FD2351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439951" y="495490"/>
          <a:ext cx="2457454" cy="28492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3076639" imgH="3566627" progId="Prism10.Document">
                  <p:embed/>
                </p:oleObj>
              </mc:Choice>
              <mc:Fallback>
                <p:oleObj name="Prism 10" r:id="rId7" imgW="3076639" imgH="3566627" progId="Prism10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32CF915E-29E3-7B56-A33A-E34A9FD2351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439951" y="495490"/>
                        <a:ext cx="2457454" cy="28492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B2855042-A32C-EDDA-CCFE-2D6BB73EDD3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271737" y="3546050"/>
          <a:ext cx="2484973" cy="28492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2966798" imgH="3402085" progId="Prism10.Document">
                  <p:embed/>
                </p:oleObj>
              </mc:Choice>
              <mc:Fallback>
                <p:oleObj name="Prism 10" r:id="rId9" imgW="2966798" imgH="3402085" progId="Prism10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B2855042-A32C-EDDA-CCFE-2D6BB73EDD3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271737" y="3546050"/>
                        <a:ext cx="2484973" cy="28492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01BF992E-3633-A0E8-D4F8-6A63B8BD625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4109246"/>
              </p:ext>
            </p:extLst>
          </p:nvPr>
        </p:nvGraphicFramePr>
        <p:xfrm>
          <a:off x="7127985" y="3585401"/>
          <a:ext cx="2629882" cy="28492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1" imgW="2912057" imgH="3155093" progId="Prism10.Document">
                  <p:embed/>
                </p:oleObj>
              </mc:Choice>
              <mc:Fallback>
                <p:oleObj name="Prism 10" r:id="rId11" imgW="2912057" imgH="3155093" progId="Prism10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01BF992E-3633-A0E8-D4F8-6A63B8BD625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7127985" y="3585401"/>
                        <a:ext cx="2629882" cy="28492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BDB8E854-F4D3-5C1F-00E9-8352AB4233C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38533654"/>
              </p:ext>
            </p:extLst>
          </p:nvPr>
        </p:nvGraphicFramePr>
        <p:xfrm>
          <a:off x="6998735" y="495490"/>
          <a:ext cx="2593732" cy="28492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3" imgW="3012535" imgH="3310633" progId="Prism10.Document">
                  <p:embed/>
                </p:oleObj>
              </mc:Choice>
              <mc:Fallback>
                <p:oleObj name="Prism 10" r:id="rId13" imgW="3012535" imgH="3310633" progId="Prism10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BDB8E854-F4D3-5C1F-00E9-8352AB4233C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6998735" y="495490"/>
                        <a:ext cx="2593732" cy="28492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0ADD7F22-7EEE-CC09-8841-066652288216}"/>
              </a:ext>
            </a:extLst>
          </p:cNvPr>
          <p:cNvSpPr txBox="1"/>
          <p:nvPr/>
        </p:nvSpPr>
        <p:spPr>
          <a:xfrm>
            <a:off x="245274" y="310824"/>
            <a:ext cx="2670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Figure S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487092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5CDFA0F-FEC2-3E18-DC81-DDA8DB4EF0F9}"/>
              </a:ext>
            </a:extLst>
          </p:cNvPr>
          <p:cNvSpPr txBox="1"/>
          <p:nvPr/>
        </p:nvSpPr>
        <p:spPr>
          <a:xfrm>
            <a:off x="1775637" y="2551837"/>
            <a:ext cx="8708065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l Figure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2. 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Effect of HLA-A*0201 Y320 Mutations on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xpression Level 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of Selected Genes in Human Primed Antigen-Specific CD8+ T Cells. </a:t>
            </a:r>
            <a:r>
              <a:rPr lang="en-US" sz="1800" b="0" dirty="0">
                <a:latin typeface="Arial" panose="020B0604020202020204" pitchFamily="34" charset="0"/>
                <a:cs typeface="Arial" panose="020B0604020202020204" pitchFamily="34" charset="0"/>
              </a:rPr>
              <a:t>PBMC from 3 healthy donors were stimulated twice with KG-1 cells expressing WT, Y320F, or Y320E SCTs bearing FluM1 peptide, then CD8+/tetramer+ cells were sorted for RNA-Seq. Each data point represents the value for an individual donor, with paired comparisons performed using a two-tailed paired Student’s t-test. Data are presented as mean ± standard error of the mean (SEM) from n = 3 donors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56211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4595CE38-3E02-714B-D8BD-CFCB26FAAC4C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255" r="56917"/>
          <a:stretch/>
        </p:blipFill>
        <p:spPr>
          <a:xfrm>
            <a:off x="1279819" y="3061409"/>
            <a:ext cx="1698641" cy="162605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6F52B4A-6AEC-F05B-C935-61B22B1822B2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168" r="56572"/>
          <a:stretch/>
        </p:blipFill>
        <p:spPr>
          <a:xfrm>
            <a:off x="1279820" y="4741933"/>
            <a:ext cx="1829848" cy="1660322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6797824E-314D-7316-86D7-7EA3B9C372B9}"/>
              </a:ext>
            </a:extLst>
          </p:cNvPr>
          <p:cNvSpPr/>
          <p:nvPr/>
        </p:nvSpPr>
        <p:spPr>
          <a:xfrm>
            <a:off x="520694" y="3497017"/>
            <a:ext cx="759125" cy="30192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ysClr val="windowText" lastClr="000000"/>
                </a:solidFill>
              </a:rPr>
              <a:t>0 min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7A0361C6-A63D-46A1-00A3-A6A0C90BFC3F}"/>
              </a:ext>
            </a:extLst>
          </p:cNvPr>
          <p:cNvSpPr/>
          <p:nvPr/>
        </p:nvSpPr>
        <p:spPr>
          <a:xfrm>
            <a:off x="520694" y="5207896"/>
            <a:ext cx="897147" cy="30192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ysClr val="windowText" lastClr="000000"/>
                </a:solidFill>
              </a:rPr>
              <a:t>60 min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CC1B6717-61D4-C85A-37BD-3A66268B4CF2}"/>
              </a:ext>
            </a:extLst>
          </p:cNvPr>
          <p:cNvSpPr/>
          <p:nvPr/>
        </p:nvSpPr>
        <p:spPr>
          <a:xfrm>
            <a:off x="6689535" y="1433796"/>
            <a:ext cx="848923" cy="33892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dirty="0">
                <a:solidFill>
                  <a:schemeClr val="tx1"/>
                </a:solidFill>
              </a:rPr>
              <a:t>WT</a:t>
            </a:r>
            <a:endParaRPr lang="en-US" sz="1600" b="1" dirty="0">
              <a:solidFill>
                <a:schemeClr val="tx1"/>
              </a:solidFill>
            </a:endParaRP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D748677A-71CC-C0F5-A153-C23315406283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6267"/>
          <a:stretch/>
        </p:blipFill>
        <p:spPr>
          <a:xfrm>
            <a:off x="6343611" y="1810124"/>
            <a:ext cx="1540772" cy="1698787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7824A2B4-8520-AF3E-027E-5DB0BDE46A0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-20000"/>
                    </a14:imgEffect>
                  </a14:imgLayer>
                </a14:imgProps>
              </a:ext>
            </a:extLst>
          </a:blip>
          <a:srcRect l="588" r="9773"/>
          <a:stretch/>
        </p:blipFill>
        <p:spPr>
          <a:xfrm>
            <a:off x="6343611" y="3626245"/>
            <a:ext cx="1540772" cy="1698787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29BD7DEE-755F-3B3D-6741-27C3201749C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-20000"/>
                    </a14:imgEffect>
                  </a14:imgLayer>
                </a14:imgProps>
              </a:ext>
            </a:extLst>
          </a:blip>
          <a:srcRect r="2523"/>
          <a:stretch/>
        </p:blipFill>
        <p:spPr>
          <a:xfrm>
            <a:off x="9607497" y="1810123"/>
            <a:ext cx="1540772" cy="1698787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662AA343-3520-BBA7-6FCC-C21F00AB93E9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rcRect l="4905"/>
          <a:stretch/>
        </p:blipFill>
        <p:spPr>
          <a:xfrm>
            <a:off x="9607497" y="3626244"/>
            <a:ext cx="1540772" cy="1698787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F0599C4C-8C9D-8C5C-911B-CD55ED8AEBD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975554" y="1810124"/>
            <a:ext cx="1540772" cy="1698787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0469E4DC-C483-5783-AD46-BA22A1ECDAA0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rcRect t="3863"/>
          <a:stretch/>
        </p:blipFill>
        <p:spPr>
          <a:xfrm>
            <a:off x="7975554" y="3626244"/>
            <a:ext cx="1540772" cy="1698787"/>
          </a:xfrm>
          <a:prstGeom prst="rect">
            <a:avLst/>
          </a:prstGeom>
        </p:spPr>
      </p:pic>
      <p:sp>
        <p:nvSpPr>
          <p:cNvPr id="29" name="Rectangle 28">
            <a:extLst>
              <a:ext uri="{FF2B5EF4-FFF2-40B4-BE49-F238E27FC236}">
                <a16:creationId xmlns:a16="http://schemas.microsoft.com/office/drawing/2014/main" id="{8F23D1C0-568A-F410-340F-89C5E5968100}"/>
              </a:ext>
            </a:extLst>
          </p:cNvPr>
          <p:cNvSpPr/>
          <p:nvPr/>
        </p:nvSpPr>
        <p:spPr>
          <a:xfrm>
            <a:off x="8321478" y="1436125"/>
            <a:ext cx="848923" cy="33892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</a:rPr>
              <a:t>Y320F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2B8E5856-4AF9-D516-6CCD-0A4D4EB8E489}"/>
              </a:ext>
            </a:extLst>
          </p:cNvPr>
          <p:cNvSpPr/>
          <p:nvPr/>
        </p:nvSpPr>
        <p:spPr>
          <a:xfrm>
            <a:off x="9854093" y="1412534"/>
            <a:ext cx="848923" cy="33892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</a:rPr>
              <a:t>Y320E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1A5EA24-969A-B088-0D2C-CEC15EA39EAC}"/>
              </a:ext>
            </a:extLst>
          </p:cNvPr>
          <p:cNvSpPr txBox="1"/>
          <p:nvPr/>
        </p:nvSpPr>
        <p:spPr>
          <a:xfrm>
            <a:off x="520694" y="51543"/>
            <a:ext cx="2670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Figure S3</a:t>
            </a:r>
            <a:endParaRPr lang="en-US" dirty="0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FD850C67-3C84-A17D-C140-F760BD156087}"/>
              </a:ext>
            </a:extLst>
          </p:cNvPr>
          <p:cNvSpPr/>
          <p:nvPr/>
        </p:nvSpPr>
        <p:spPr>
          <a:xfrm>
            <a:off x="176254" y="2604583"/>
            <a:ext cx="415024" cy="29206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B.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DD446838-7B5D-B3FB-620E-4A33CD695AF8}"/>
              </a:ext>
            </a:extLst>
          </p:cNvPr>
          <p:cNvSpPr/>
          <p:nvPr/>
        </p:nvSpPr>
        <p:spPr>
          <a:xfrm>
            <a:off x="5311483" y="1323501"/>
            <a:ext cx="415024" cy="22059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C.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AD76723B-853F-084C-24D7-5BF950E81C44}"/>
              </a:ext>
            </a:extLst>
          </p:cNvPr>
          <p:cNvSpPr/>
          <p:nvPr/>
        </p:nvSpPr>
        <p:spPr>
          <a:xfrm>
            <a:off x="5499461" y="2441775"/>
            <a:ext cx="848923" cy="33892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dirty="0">
                <a:solidFill>
                  <a:schemeClr val="tx1"/>
                </a:solidFill>
              </a:rPr>
              <a:t>0 min</a:t>
            </a:r>
            <a:endParaRPr lang="en-US" sz="1600" b="1" dirty="0">
              <a:solidFill>
                <a:schemeClr val="tx1"/>
              </a:solidFill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CBA09F73-914B-FC66-E678-BCA175F79901}"/>
              </a:ext>
            </a:extLst>
          </p:cNvPr>
          <p:cNvSpPr/>
          <p:nvPr/>
        </p:nvSpPr>
        <p:spPr>
          <a:xfrm>
            <a:off x="5518995" y="4306176"/>
            <a:ext cx="848923" cy="33892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dirty="0">
                <a:solidFill>
                  <a:schemeClr val="tx1"/>
                </a:solidFill>
              </a:rPr>
              <a:t>60 min</a:t>
            </a:r>
            <a:endParaRPr lang="en-US" sz="1600" b="1" dirty="0">
              <a:solidFill>
                <a:schemeClr val="tx1"/>
              </a:solidFill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36EE5822-183F-E2FD-509C-29AB147BB27B}"/>
              </a:ext>
            </a:extLst>
          </p:cNvPr>
          <p:cNvSpPr/>
          <p:nvPr/>
        </p:nvSpPr>
        <p:spPr>
          <a:xfrm>
            <a:off x="176254" y="594777"/>
            <a:ext cx="415024" cy="29206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>
                <a:solidFill>
                  <a:schemeClr val="tx1"/>
                </a:solidFill>
              </a:rPr>
              <a:t>A</a:t>
            </a:r>
            <a:r>
              <a:rPr lang="en-US" dirty="0">
                <a:solidFill>
                  <a:schemeClr val="tx1"/>
                </a:solidFill>
              </a:rPr>
              <a:t>.</a:t>
            </a:r>
          </a:p>
        </p:txBody>
      </p:sp>
      <p:pic>
        <p:nvPicPr>
          <p:cNvPr id="19" name="Picture 18" descr="A diagram of a cell&#10;&#10;AI-generated content may be incorrect.">
            <a:extLst>
              <a:ext uri="{FF2B5EF4-FFF2-40B4-BE49-F238E27FC236}">
                <a16:creationId xmlns:a16="http://schemas.microsoft.com/office/drawing/2014/main" id="{6C7AF66B-A8C7-3595-23D6-972147685F87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83" t="24759" r="42470" b="25298"/>
          <a:stretch/>
        </p:blipFill>
        <p:spPr>
          <a:xfrm>
            <a:off x="1113685" y="706154"/>
            <a:ext cx="1527014" cy="1544771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51DD2EB5-476E-E68E-0AF0-ABB4D6EDCF1A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799083" y="929014"/>
            <a:ext cx="1573677" cy="1455228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B8F8A8E0-E9FC-E359-BE45-44FEA2450899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069631" y="3364090"/>
            <a:ext cx="1222084" cy="869704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22080842-5088-BE2A-7762-94925F911766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056853" y="5074968"/>
            <a:ext cx="1218337" cy="8697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485988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F4F90D9-8934-2999-D312-C7BEB44C633F}"/>
              </a:ext>
            </a:extLst>
          </p:cNvPr>
          <p:cNvSpPr txBox="1"/>
          <p:nvPr/>
        </p:nvSpPr>
        <p:spPr>
          <a:xfrm>
            <a:off x="1690575" y="1789407"/>
            <a:ext cx="9508801" cy="23083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dirty="0"/>
              <a:t>Supplemental Figure S3. Surface OVA-</a:t>
            </a:r>
            <a:r>
              <a:rPr lang="en-US" b="1" dirty="0" err="1"/>
              <a:t>Kb</a:t>
            </a:r>
            <a:r>
              <a:rPr lang="en-US" b="1" dirty="0"/>
              <a:t> Expression and Cell Surface Internalization</a:t>
            </a:r>
            <a:r>
              <a:rPr lang="en-US" dirty="0"/>
              <a:t>. </a:t>
            </a:r>
          </a:p>
          <a:p>
            <a:pPr algn="just"/>
            <a:r>
              <a:rPr lang="en-US" b="1" dirty="0"/>
              <a:t>(A) </a:t>
            </a:r>
            <a:r>
              <a:rPr lang="en-US" dirty="0"/>
              <a:t>Schematics of the SCTs and surface expression of OVA-</a:t>
            </a:r>
            <a:r>
              <a:rPr lang="en-US" dirty="0" err="1"/>
              <a:t>Kb</a:t>
            </a:r>
            <a:r>
              <a:rPr lang="en-US" dirty="0"/>
              <a:t> on cells assessed by flow cytometry.</a:t>
            </a:r>
            <a:r>
              <a:rPr lang="en-US" b="1" dirty="0"/>
              <a:t> (B) </a:t>
            </a:r>
            <a:r>
              <a:rPr lang="en-US" dirty="0"/>
              <a:t>Flow cytometric analysis of surface H2-K^b–OVA SCT internalization. APC vs. FITC fluorescence ratios were measured at 0 and 60 min to quantify internalization across WT, Y320F, and Y320E constructs. Median APC/FITC ratios are shown in the accompanying tables. </a:t>
            </a:r>
            <a:r>
              <a:rPr lang="en-US" b="1" dirty="0"/>
              <a:t>(C) </a:t>
            </a:r>
            <a:r>
              <a:rPr lang="en-US" dirty="0"/>
              <a:t>Confocal microscopy images of surface H2-K^b–OVA SCT internalization at 0 and 60 min. Internalized molecules are labeled in green, surface-retained molecules are labeled in red (secondary antibody), and merged signals appear orange. Nuclei are counterstained in blue.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92648568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59BC2748-DA1C-6338-1AFF-CC417FCF95F9}"/>
              </a:ext>
            </a:extLst>
          </p:cNvPr>
          <p:cNvSpPr/>
          <p:nvPr/>
        </p:nvSpPr>
        <p:spPr>
          <a:xfrm>
            <a:off x="210785" y="783055"/>
            <a:ext cx="415024" cy="29206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A.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E0D340F4-65F9-C82C-E355-448A3429BD6A}"/>
              </a:ext>
            </a:extLst>
          </p:cNvPr>
          <p:cNvSpPr/>
          <p:nvPr/>
        </p:nvSpPr>
        <p:spPr>
          <a:xfrm>
            <a:off x="7085656" y="663439"/>
            <a:ext cx="415024" cy="29206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B.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1272F44B-D1B8-034C-3852-8CE2EF640133}"/>
              </a:ext>
            </a:extLst>
          </p:cNvPr>
          <p:cNvSpPr/>
          <p:nvPr/>
        </p:nvSpPr>
        <p:spPr>
          <a:xfrm>
            <a:off x="2753723" y="1338660"/>
            <a:ext cx="373055" cy="4709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782C7183-A670-8885-C00C-B662A888A4AD}"/>
              </a:ext>
            </a:extLst>
          </p:cNvPr>
          <p:cNvSpPr/>
          <p:nvPr/>
        </p:nvSpPr>
        <p:spPr>
          <a:xfrm>
            <a:off x="2693588" y="3366396"/>
            <a:ext cx="373055" cy="4709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62E30ECA-773A-18F0-AB34-A1E08B22DFE8}"/>
              </a:ext>
            </a:extLst>
          </p:cNvPr>
          <p:cNvSpPr/>
          <p:nvPr/>
        </p:nvSpPr>
        <p:spPr>
          <a:xfrm>
            <a:off x="4757003" y="3239756"/>
            <a:ext cx="373055" cy="4709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4AD2FD13-6780-D653-69EA-0DECE6330DAF}"/>
              </a:ext>
            </a:extLst>
          </p:cNvPr>
          <p:cNvSpPr/>
          <p:nvPr/>
        </p:nvSpPr>
        <p:spPr>
          <a:xfrm>
            <a:off x="4726716" y="3314521"/>
            <a:ext cx="373055" cy="4709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DE40715C-CBEB-DBAC-5E58-084258E19A89}"/>
              </a:ext>
            </a:extLst>
          </p:cNvPr>
          <p:cNvSpPr/>
          <p:nvPr/>
        </p:nvSpPr>
        <p:spPr>
          <a:xfrm>
            <a:off x="9454667" y="1075116"/>
            <a:ext cx="353322" cy="3534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BEC82084-91D5-9F06-8E21-8C171852B7D8}"/>
              </a:ext>
            </a:extLst>
          </p:cNvPr>
          <p:cNvSpPr/>
          <p:nvPr/>
        </p:nvSpPr>
        <p:spPr>
          <a:xfrm>
            <a:off x="9445818" y="2891324"/>
            <a:ext cx="353322" cy="3534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88611BF0-BEA5-4A9A-5A07-EDAF10C60DAF}"/>
              </a:ext>
            </a:extLst>
          </p:cNvPr>
          <p:cNvSpPr/>
          <p:nvPr/>
        </p:nvSpPr>
        <p:spPr>
          <a:xfrm>
            <a:off x="9559044" y="4763007"/>
            <a:ext cx="353322" cy="3534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2881941F-DB66-5D8E-5C50-5897E183E9A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8238" y="1098114"/>
            <a:ext cx="2165389" cy="2024423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4335D0C5-6AD7-7699-703C-6BEA22AF7C0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43550" y="1124862"/>
            <a:ext cx="2191604" cy="2001871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A3A96433-0E7B-267B-D053-2B4FC070775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55077" y="1102644"/>
            <a:ext cx="2165389" cy="1977926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26523F97-B307-C215-AAE5-E46D32A34FF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68941" y="3160507"/>
            <a:ext cx="2216872" cy="1986348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E92FA2E6-8880-55A8-8850-B72E2F3B8DC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71043" y="3113712"/>
            <a:ext cx="2203947" cy="2024423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2B9BE1B2-0755-0D23-5D14-48B97707CA45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b="10569"/>
          <a:stretch/>
        </p:blipFill>
        <p:spPr>
          <a:xfrm>
            <a:off x="4444263" y="3068033"/>
            <a:ext cx="2339985" cy="1882314"/>
          </a:xfrm>
          <a:prstGeom prst="rect">
            <a:avLst/>
          </a:prstGeom>
        </p:spPr>
      </p:pic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000885FC-46E3-A94A-5F1A-B14A4AA7445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02835062"/>
              </p:ext>
            </p:extLst>
          </p:nvPr>
        </p:nvGraphicFramePr>
        <p:xfrm>
          <a:off x="7316168" y="773986"/>
          <a:ext cx="2164253" cy="19347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3652857" imgH="3264907" progId="Prism10.Document">
                  <p:embed/>
                </p:oleObj>
              </mc:Choice>
              <mc:Fallback>
                <p:oleObj name="Prism 10" r:id="rId9" imgW="3652857" imgH="3264907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316168" y="773986"/>
                        <a:ext cx="2164253" cy="19347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6" name="Picture 25">
            <a:extLst>
              <a:ext uri="{FF2B5EF4-FFF2-40B4-BE49-F238E27FC236}">
                <a16:creationId xmlns:a16="http://schemas.microsoft.com/office/drawing/2014/main" id="{55D8D148-54D2-CD26-788E-CA5C126E786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330127" y="2613567"/>
            <a:ext cx="2182723" cy="1909883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B46E6807-EEFE-9043-CDAB-B69D6E8108E7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322924" y="4449363"/>
            <a:ext cx="2163920" cy="1934755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6D1086D1-64D4-BAB4-8F81-4259DE8903DE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9438277" y="752900"/>
            <a:ext cx="2184315" cy="1953790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8C169516-ACAA-D1D9-AC1B-70522A97833A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9483967" y="2613568"/>
            <a:ext cx="2243285" cy="1948320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A1EFB426-4B37-96AE-171F-F281E2AD4536}"/>
              </a:ext>
            </a:extLst>
          </p:cNvPr>
          <p:cNvPicPr>
            <a:picLocks noChangeAspect="1"/>
          </p:cNvPicPr>
          <p:nvPr/>
        </p:nvPicPr>
        <p:blipFill>
          <a:blip r:embed="rId15"/>
          <a:srcRect b="10499"/>
          <a:stretch/>
        </p:blipFill>
        <p:spPr>
          <a:xfrm>
            <a:off x="9497592" y="4504217"/>
            <a:ext cx="2163920" cy="168878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AFFF575-9316-5221-C90F-2F094B03C287}"/>
              </a:ext>
            </a:extLst>
          </p:cNvPr>
          <p:cNvSpPr txBox="1"/>
          <p:nvPr/>
        </p:nvSpPr>
        <p:spPr>
          <a:xfrm>
            <a:off x="362371" y="103485"/>
            <a:ext cx="2670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Figure S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3094174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4E8FAD2-8AF1-92A1-2D9A-D3CF81C7716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1C0AB1F-D60E-0F7D-2E4D-A64F393CEFB4}"/>
              </a:ext>
            </a:extLst>
          </p:cNvPr>
          <p:cNvSpPr txBox="1"/>
          <p:nvPr/>
        </p:nvSpPr>
        <p:spPr>
          <a:xfrm>
            <a:off x="1673123" y="2274838"/>
            <a:ext cx="9175898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dirty="0"/>
              <a:t>Supplemental Figure S4. Phenotypic Analysis of OVA-Specific T Cells Post-Vaccination</a:t>
            </a:r>
            <a:r>
              <a:rPr lang="en-US" dirty="0"/>
              <a:t>. </a:t>
            </a:r>
            <a:r>
              <a:rPr lang="en-US" b="1" dirty="0"/>
              <a:t>(A) </a:t>
            </a:r>
            <a:r>
              <a:rPr lang="en-US" dirty="0"/>
              <a:t>Relative frequency of CD127+ and </a:t>
            </a:r>
            <a:r>
              <a:rPr lang="en-US" b="1" dirty="0"/>
              <a:t>(B) </a:t>
            </a:r>
            <a:r>
              <a:rPr lang="en-US" dirty="0"/>
              <a:t>KLRG1+ cells in donor and endogenous peripheral OVA-specific T cells across different vaccination groups at various time points. Statistical differences between Y320 mutants were assessed using one-way ANOVA, followed by pairwise comparisons using an unpaired two-tailed t-test;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nly significant p values (p &lt; 0.05) are shown</a:t>
            </a:r>
            <a:r>
              <a:rPr lang="en-US" dirty="0"/>
              <a:t>.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Data are presented as mean ± standard error of the mean (SEM). </a:t>
            </a:r>
            <a:endParaRPr lang="en-US" dirty="0"/>
          </a:p>
          <a:p>
            <a:pPr algn="just"/>
            <a:endParaRPr lang="en-US" sz="18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176256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BF70D09F-9A1F-475F-A60F-3F70B68994E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78120240"/>
              </p:ext>
            </p:extLst>
          </p:nvPr>
        </p:nvGraphicFramePr>
        <p:xfrm>
          <a:off x="4470315" y="475095"/>
          <a:ext cx="3856038" cy="31529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648175" imgH="2982991" progId="Prism10.Document">
                  <p:embed/>
                </p:oleObj>
              </mc:Choice>
              <mc:Fallback>
                <p:oleObj name="Prism 10" r:id="rId2" imgW="3648175" imgH="2982991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8399F56D-E118-DC16-FFC2-751358F4C4B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470315" y="475095"/>
                        <a:ext cx="3856038" cy="31529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" name="Picture 4">
            <a:extLst>
              <a:ext uri="{FF2B5EF4-FFF2-40B4-BE49-F238E27FC236}">
                <a16:creationId xmlns:a16="http://schemas.microsoft.com/office/drawing/2014/main" id="{F36C5B2D-1B6C-7F9D-5A1D-CAB245DA13E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36792" y="3599575"/>
            <a:ext cx="3676913" cy="311479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2A5D32D-EB4A-1351-6A5C-B7AA22A3492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59877" y="3599576"/>
            <a:ext cx="3676914" cy="309600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2617DE5-ADAC-98AB-E227-AB632616075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236793" y="503573"/>
            <a:ext cx="3676913" cy="3114795"/>
          </a:xfrm>
          <a:prstGeom prst="rect">
            <a:avLst/>
          </a:prstGeom>
        </p:spPr>
      </p:pic>
      <p:grpSp>
        <p:nvGrpSpPr>
          <p:cNvPr id="11" name="Group 10">
            <a:extLst>
              <a:ext uri="{FF2B5EF4-FFF2-40B4-BE49-F238E27FC236}">
                <a16:creationId xmlns:a16="http://schemas.microsoft.com/office/drawing/2014/main" id="{DEF77E30-5FD6-B0E4-CF19-02E7B8135B7C}"/>
              </a:ext>
            </a:extLst>
          </p:cNvPr>
          <p:cNvGrpSpPr/>
          <p:nvPr/>
        </p:nvGrpSpPr>
        <p:grpSpPr>
          <a:xfrm>
            <a:off x="614725" y="1955322"/>
            <a:ext cx="3188250" cy="2625304"/>
            <a:chOff x="614725" y="1955322"/>
            <a:chExt cx="3188250" cy="2625304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0DBB190A-4DA6-3980-2F0D-CC377F50708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 r="65150"/>
            <a:stretch/>
          </p:blipFill>
          <p:spPr>
            <a:xfrm>
              <a:off x="614725" y="1955323"/>
              <a:ext cx="2094919" cy="2625303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2E4E6E5B-FC15-EE26-9FC7-F488BC38E13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 l="49817" r="25944"/>
            <a:stretch/>
          </p:blipFill>
          <p:spPr>
            <a:xfrm>
              <a:off x="2345928" y="1955322"/>
              <a:ext cx="1457047" cy="2625303"/>
            </a:xfrm>
            <a:prstGeom prst="rect">
              <a:avLst/>
            </a:prstGeom>
          </p:spPr>
        </p:pic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8B3A7C98-FCA0-EF27-EAF2-BA25ED178888}"/>
              </a:ext>
            </a:extLst>
          </p:cNvPr>
          <p:cNvSpPr txBox="1"/>
          <p:nvPr/>
        </p:nvSpPr>
        <p:spPr>
          <a:xfrm>
            <a:off x="251012" y="151423"/>
            <a:ext cx="2670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Figure S5</a:t>
            </a:r>
            <a:endParaRPr lang="en-US" dirty="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DB79D8CC-875B-646B-D3D1-B5F4295A2C5C}"/>
              </a:ext>
            </a:extLst>
          </p:cNvPr>
          <p:cNvSpPr/>
          <p:nvPr/>
        </p:nvSpPr>
        <p:spPr>
          <a:xfrm>
            <a:off x="407213" y="520755"/>
            <a:ext cx="415024" cy="29206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A.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C758804E-1295-D9DD-37B6-BCB4C308DEF0}"/>
              </a:ext>
            </a:extLst>
          </p:cNvPr>
          <p:cNvSpPr/>
          <p:nvPr/>
        </p:nvSpPr>
        <p:spPr>
          <a:xfrm>
            <a:off x="3939112" y="520755"/>
            <a:ext cx="415024" cy="29206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8299027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630</TotalTime>
  <Words>1057</Words>
  <Application>Microsoft Office PowerPoint</Application>
  <PresentationFormat>Widescreen</PresentationFormat>
  <Paragraphs>39</Paragraphs>
  <Slides>12</Slides>
  <Notes>4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8" baseType="lpstr">
      <vt:lpstr>Aptos</vt:lpstr>
      <vt:lpstr>Aptos Display</vt:lpstr>
      <vt:lpstr>Arial</vt:lpstr>
      <vt:lpstr>Calibri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.D. Anderson Cancer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un,Yimo</dc:creator>
  <cp:lastModifiedBy>Sun,Yimo</cp:lastModifiedBy>
  <cp:revision>46</cp:revision>
  <dcterms:created xsi:type="dcterms:W3CDTF">2025-03-08T20:54:51Z</dcterms:created>
  <dcterms:modified xsi:type="dcterms:W3CDTF">2025-09-16T02:20:12Z</dcterms:modified>
</cp:coreProperties>
</file>